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65" autoAdjust="0"/>
    <p:restoredTop sz="94660"/>
  </p:normalViewPr>
  <p:slideViewPr>
    <p:cSldViewPr snapToGrid="0">
      <p:cViewPr>
        <p:scale>
          <a:sx n="83" d="100"/>
          <a:sy n="83" d="100"/>
        </p:scale>
        <p:origin x="1459" y="-1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496484"/>
            <a:ext cx="7772400" cy="31834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802717"/>
            <a:ext cx="6858000" cy="220768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2E3E1-A9FD-4EE4-BE2C-C0A2312E30CE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8596B-2590-4D32-9963-7F8E94BAC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335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2E3E1-A9FD-4EE4-BE2C-C0A2312E30CE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8596B-2590-4D32-9963-7F8E94BAC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73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86834"/>
            <a:ext cx="1971675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86834"/>
            <a:ext cx="5800725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2E3E1-A9FD-4EE4-BE2C-C0A2312E30CE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8596B-2590-4D32-9963-7F8E94BAC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7837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2E3E1-A9FD-4EE4-BE2C-C0A2312E30CE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8596B-2590-4D32-9963-7F8E94BAC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77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279653"/>
            <a:ext cx="7886700" cy="380364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6119286"/>
            <a:ext cx="7886700" cy="20002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2E3E1-A9FD-4EE4-BE2C-C0A2312E30CE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8596B-2590-4D32-9963-7F8E94BAC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736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434167"/>
            <a:ext cx="388620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434167"/>
            <a:ext cx="388620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2E3E1-A9FD-4EE4-BE2C-C0A2312E30CE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8596B-2590-4D32-9963-7F8E94BAC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289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86836"/>
            <a:ext cx="78867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241551"/>
            <a:ext cx="3868340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340100"/>
            <a:ext cx="3868340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241551"/>
            <a:ext cx="3887391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340100"/>
            <a:ext cx="3887391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2E3E1-A9FD-4EE4-BE2C-C0A2312E30CE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8596B-2590-4D32-9963-7F8E94BAC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236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2E3E1-A9FD-4EE4-BE2C-C0A2312E30CE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8596B-2590-4D32-9963-7F8E94BAC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996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2E3E1-A9FD-4EE4-BE2C-C0A2312E30CE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8596B-2590-4D32-9963-7F8E94BAC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392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09600"/>
            <a:ext cx="294917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316569"/>
            <a:ext cx="4629150" cy="6498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743200"/>
            <a:ext cx="2949178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2E3E1-A9FD-4EE4-BE2C-C0A2312E30CE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8596B-2590-4D32-9963-7F8E94BAC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413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09600"/>
            <a:ext cx="294917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316569"/>
            <a:ext cx="4629150" cy="649816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743200"/>
            <a:ext cx="2949178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2E3E1-A9FD-4EE4-BE2C-C0A2312E30CE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8596B-2590-4D32-9963-7F8E94BAC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112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486836"/>
            <a:ext cx="78867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434167"/>
            <a:ext cx="78867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8475136"/>
            <a:ext cx="20574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02E3E1-A9FD-4EE4-BE2C-C0A2312E30CE}" type="datetimeFigureOut">
              <a:rPr lang="en-US" smtClean="0"/>
              <a:t>5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8475136"/>
            <a:ext cx="30861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8475136"/>
            <a:ext cx="20574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68596B-2590-4D32-9963-7F8E94BAC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671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3C3C0758-6F7A-4116-A6D9-A9F851723138}"/>
              </a:ext>
            </a:extLst>
          </p:cNvPr>
          <p:cNvSpPr/>
          <p:nvPr/>
        </p:nvSpPr>
        <p:spPr>
          <a:xfrm>
            <a:off x="355255" y="8497669"/>
            <a:ext cx="861464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ltiple sequence alignment of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ARF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s from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ficinarum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-Purple using MAFFT. Conserved domains are underlined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E5E5A4C-6204-4F1C-AA39-83A0CDF7BBD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676" r="11440" b="3916"/>
          <a:stretch/>
        </p:blipFill>
        <p:spPr>
          <a:xfrm>
            <a:off x="2095500" y="0"/>
            <a:ext cx="4831080" cy="85433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51350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2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mad Ali</dc:creator>
  <cp:lastModifiedBy>Ahmad Ali</cp:lastModifiedBy>
  <cp:revision>6</cp:revision>
  <dcterms:created xsi:type="dcterms:W3CDTF">2026-04-02T02:56:22Z</dcterms:created>
  <dcterms:modified xsi:type="dcterms:W3CDTF">2026-05-06T06:46:37Z</dcterms:modified>
</cp:coreProperties>
</file>